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2" d="100"/>
          <a:sy n="52" d="100"/>
        </p:scale>
        <p:origin x="206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0798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814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3393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366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873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86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6643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0714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7449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5001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1661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99D1C-EEAD-4629-ABBE-7C3C1A216EFB}" type="datetimeFigureOut">
              <a:rPr lang="zh-CN" altLang="en-US" smtClean="0"/>
              <a:t>2022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8F2598-E57A-42A2-9E63-4EEB03F4FA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3709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340243" y="6459278"/>
            <a:ext cx="632105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b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RNA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idation in tumor tissues from TCGA-PRAD data (A)The expression levels of the 8 hub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RNA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I-IIIA stage  and IIIB-IV stage group of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B) RFS curve of the 8 hub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RNA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Kaplan–Meier analysis and log-rank test. Patients were divided into the high expression level and the low expression level based on the median value in I-IIIA stage or IIIB-IV stage group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870" y="1038606"/>
            <a:ext cx="6472428" cy="41711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8695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77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ANG WEIHUA</dc:creator>
  <cp:lastModifiedBy>HUANG WEIHUA</cp:lastModifiedBy>
  <cp:revision>2</cp:revision>
  <dcterms:created xsi:type="dcterms:W3CDTF">2022-11-18T00:54:28Z</dcterms:created>
  <dcterms:modified xsi:type="dcterms:W3CDTF">2022-11-18T00:57:58Z</dcterms:modified>
</cp:coreProperties>
</file>